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578" y="2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9331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073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1" y="304800"/>
            <a:ext cx="1543050" cy="65024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1" y="304800"/>
            <a:ext cx="4514850" cy="65024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2008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484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6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2714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1" y="1778000"/>
            <a:ext cx="3028950" cy="50292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1" y="1778000"/>
            <a:ext cx="3028950" cy="50292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796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2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2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4184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6159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7001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2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5216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5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2661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83E1C-FFAF-4F7B-AF82-FC77679355BF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B7EF1-D1CD-49EB-9E8A-1DD14F26DE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6444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2 Marcador de contenido"/>
          <p:cNvSpPr>
            <a:spLocks noGrp="1"/>
          </p:cNvSpPr>
          <p:nvPr>
            <p:ph idx="1"/>
          </p:nvPr>
        </p:nvSpPr>
        <p:spPr>
          <a:xfrm>
            <a:off x="457200" y="609600"/>
            <a:ext cx="5867400" cy="5516563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s-ES" sz="1200" b="1" dirty="0" err="1">
                <a:latin typeface="Arial" pitchFamily="34" charset="0"/>
                <a:cs typeface="Arial" pitchFamily="34" charset="0"/>
              </a:rPr>
              <a:t>Linkag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isequilibrium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patterns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populatio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structur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iversity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in a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worldwid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urum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collectio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including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Argentinia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genotypes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Pablo Federico Roncallo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Adelina Olga Larsen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Ana Laura Achilli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Carolina Saint 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Pierre</a:t>
            </a: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Cristian Andrés Gallo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Susanne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Dreisigacker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Viviana Echenique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*</a:t>
            </a: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Centro 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de Recursos Naturales Renovables de la Zona Semiárida (CERZOS), Departamento de Agronomía, Universidad Nacional del Sur (UNS)-CONICET, Bahía Blanca, Argentina.</a:t>
            </a:r>
          </a:p>
          <a:p>
            <a:pPr marL="0" indent="0">
              <a:buNone/>
            </a:pPr>
            <a:r>
              <a:rPr lang="es-ES" sz="12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CEI Barrow, Instituto Nacional de Tecnología Agropecuaria (INTA), Tres Arroyos, Buenos Aires, Argentina. </a:t>
            </a:r>
          </a:p>
          <a:p>
            <a:pPr marL="0" indent="0">
              <a:buNone/>
            </a:pP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International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Maize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Improvement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Center (CIMMYT), El Batán, Edo. de México, México.</a:t>
            </a: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*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Corresponding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author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: </a:t>
            </a:r>
          </a:p>
          <a:p>
            <a:pPr marL="0" indent="0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E-mail: echeniq@criba.edu.ar</a:t>
            </a:r>
          </a:p>
          <a:p>
            <a:endParaRPr lang="es-E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9337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Pablo\Documents\LABORAL\INVESTIGACION\PUBLICACIONES\Publicaciones en curso\2016 GENETIC STRUCTURE USING SNPs\ANALISIS\TASSEL\LD decay\LD plots by chr\Chr 1A LD plot.png"/>
          <p:cNvPicPr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46" t="2021" r="10138" b="6623"/>
          <a:stretch/>
        </p:blipFill>
        <p:spPr bwMode="auto">
          <a:xfrm>
            <a:off x="212210" y="104016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C:\Users\Pablo\Documents\LABORAL\INVESTIGACION\PUBLICACIONES\Publicaciones en curso\2016 GENETIC STRUCTURE USING SNPs\ANALISIS\TASSEL\LD decay\LD plots by chr\Chr 1B LD plot.png"/>
          <p:cNvPicPr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46" t="2858" r="11181" b="6623"/>
          <a:stretch/>
        </p:blipFill>
        <p:spPr bwMode="auto">
          <a:xfrm>
            <a:off x="212210" y="1842624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Pablo\Documents\LABORAL\INVESTIGACION\PUBLICACIONES\Publicaciones en curso\2016 GENETIC STRUCTURE USING SNPs\ANALISIS\TASSEL\LD decay\LD plots by chr\Chr 2A LD plot.png"/>
          <p:cNvPicPr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37" t="2568" r="10412" b="6629"/>
          <a:stretch/>
        </p:blipFill>
        <p:spPr bwMode="auto">
          <a:xfrm>
            <a:off x="221584" y="3592312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Pablo\Documents\LABORAL\INVESTIGACION\PUBLICACIONES\Publicaciones en curso\2016 GENETIC STRUCTURE USING SNPs\ANALISIS\TASSEL\LD decay\LD plots by chr\Chr 2B LD plot.png"/>
          <p:cNvPicPr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3" t="1887" r="11000" b="6654"/>
          <a:stretch/>
        </p:blipFill>
        <p:spPr bwMode="auto">
          <a:xfrm>
            <a:off x="228118" y="5334000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C:\Users\Pablo\Documents\LABORAL\INVESTIGACION\PUBLICACIONES\Publicaciones en curso\2016 GENETIC STRUCTURE USING SNPs\ANALISIS\TASSEL\LD decay\LD plots by chr\Chr 3A LD plot.png"/>
          <p:cNvPicPr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5" t="2823" r="11024" b="6640"/>
          <a:stretch/>
        </p:blipFill>
        <p:spPr bwMode="auto">
          <a:xfrm>
            <a:off x="215002" y="7110875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 descr="C:\Users\Pablo\Documents\LABORAL\INVESTIGACION\PUBLICACIONES\Publicaciones en curso\2016 GENETIC STRUCTURE USING SNPs\ANALISIS\TASSEL\LD decay\LD plots by chr\Chr 3B LD plot.png"/>
          <p:cNvPicPr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63" t="3052" r="11177" b="6411"/>
          <a:stretch/>
        </p:blipFill>
        <p:spPr bwMode="auto">
          <a:xfrm>
            <a:off x="2297869" y="106680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 descr="C:\Users\Pablo\Documents\LABORAL\INVESTIGACION\PUBLICACIONES\Publicaciones en curso\2016 GENETIC STRUCTURE USING SNPs\ANALISIS\TASSEL\LD decay\LD plots by chr\Chr 4A LD plot.png"/>
          <p:cNvPicPr>
            <a:picLocks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6" t="3128" r="11559" b="6946"/>
          <a:stretch/>
        </p:blipFill>
        <p:spPr bwMode="auto">
          <a:xfrm>
            <a:off x="2298143" y="1840072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C:\Users\Pablo\Documents\LABORAL\INVESTIGACION\PUBLICACIONES\Publicaciones en curso\2016 GENETIC STRUCTURE USING SNPs\ANALISIS\TASSEL\LD decay\LD plots by chr\Chr 4B LD plot.png"/>
          <p:cNvPicPr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6" t="2380" r="11712" b="6640"/>
          <a:stretch/>
        </p:blipFill>
        <p:spPr bwMode="auto">
          <a:xfrm>
            <a:off x="2312167" y="3590068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1" descr="C:\Users\Pablo\Documents\LABORAL\INVESTIGACION\PUBLICACIONES\Publicaciones en curso\2016 GENETIC STRUCTURE USING SNPs\ANALISIS\TASSEL\LD decay\LD plots by chr\Chr 5A LD plot.png"/>
          <p:cNvPicPr>
            <a:picLocks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5" t="2380" r="10642" b="6487"/>
          <a:stretch/>
        </p:blipFill>
        <p:spPr bwMode="auto">
          <a:xfrm>
            <a:off x="2321771" y="5334000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 descr="C:\Users\Pablo\Documents\LABORAL\INVESTIGACION\PUBLICACIONES\Publicaciones en curso\2016 GENETIC STRUCTURE USING SNPs\ANALISIS\TASSEL\LD decay\LD plots by chr\Chr 5B LD plot.png"/>
          <p:cNvPicPr>
            <a:picLocks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91" t="3204" r="11101" b="6564"/>
          <a:stretch/>
        </p:blipFill>
        <p:spPr bwMode="auto">
          <a:xfrm>
            <a:off x="2328798" y="7110875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3" descr="C:\Users\Pablo\Documents\LABORAL\INVESTIGACION\PUBLICACIONES\Publicaciones en curso\2016 GENETIC STRUCTURE USING SNPs\ANALISIS\TASSEL\LD decay\LD plots by chr\Chr 6A LD plot.png"/>
          <p:cNvPicPr>
            <a:picLocks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69" t="3060" r="10990" b="6502"/>
          <a:stretch/>
        </p:blipFill>
        <p:spPr bwMode="auto">
          <a:xfrm>
            <a:off x="4406603" y="101523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4" descr="C:\Users\Pablo\Documents\LABORAL\INVESTIGACION\PUBLICACIONES\Publicaciones en curso\2016 GENETIC STRUCTURE USING SNPs\ANALISIS\TASSEL\LD decay\LD plots by chr\Chr 6B LD plot.png"/>
          <p:cNvPicPr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63" t="3127" r="11330" b="6641"/>
          <a:stretch/>
        </p:blipFill>
        <p:spPr bwMode="auto">
          <a:xfrm>
            <a:off x="4406603" y="1840004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5" descr="C:\Users\Pablo\Documents\LABORAL\INVESTIGACION\PUBLICACIONES\Publicaciones en curso\2016 GENETIC STRUCTURE USING SNPs\ANALISIS\TASSEL\LD decay\LD plots by chr\Chr 7A LD plot.png"/>
          <p:cNvPicPr>
            <a:picLocks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45" t="3204" r="11330" b="6564"/>
          <a:stretch/>
        </p:blipFill>
        <p:spPr bwMode="auto">
          <a:xfrm>
            <a:off x="4404455" y="3594329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6" descr="C:\Users\Pablo\Documents\LABORAL\INVESTIGACION\PUBLICACIONES\Publicaciones en curso\2016 GENETIC STRUCTURE USING SNPs\ANALISIS\TASSEL\LD decay\LD plots by chr\Chr 7B LD plot.png"/>
          <p:cNvPicPr>
            <a:picLocks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87" t="2977" r="10948" b="6639"/>
          <a:stretch/>
        </p:blipFill>
        <p:spPr bwMode="auto">
          <a:xfrm>
            <a:off x="4410684" y="5342231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7" descr="C:\Users\Pablo\Documents\LABORAL\INVESTIGACION\PUBLICACIONES\Publicaciones en curso\2016 GENETIC STRUCTURE USING SNPs\ANALISIS\TASSEL\LD decay\LD plots by chr\Chr Unk LD plot.png"/>
          <p:cNvPicPr>
            <a:picLocks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1" t="2334" r="10738" b="6497"/>
          <a:stretch/>
        </p:blipFill>
        <p:spPr bwMode="auto">
          <a:xfrm>
            <a:off x="4428762" y="7108995"/>
            <a:ext cx="1645920" cy="1645920"/>
          </a:xfrm>
          <a:prstGeom prst="rect">
            <a:avLst/>
          </a:prstGeom>
          <a:noFill/>
          <a:ln cap="rnd">
            <a:solidFill>
              <a:schemeClr val="bg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18 CuadroTexto"/>
          <p:cNvSpPr txBox="1"/>
          <p:nvPr/>
        </p:nvSpPr>
        <p:spPr>
          <a:xfrm>
            <a:off x="1535431" y="106680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1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3592831" y="11396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3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5725210" y="11396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6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>
            <a:off x="1535431" y="1828800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1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3592831" y="18360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4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5725210" y="18360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6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1524001" y="3581400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2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3581401" y="35886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4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>
            <a:off x="5713780" y="35886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>
                <a:latin typeface="Arial" pitchFamily="34" charset="0"/>
                <a:cs typeface="Arial" pitchFamily="34" charset="0"/>
              </a:rPr>
              <a:t>7</a:t>
            </a:r>
            <a:r>
              <a:rPr lang="es-AR" sz="1100" b="1" dirty="0" smtClean="0">
                <a:latin typeface="Arial" pitchFamily="34" charset="0"/>
                <a:cs typeface="Arial" pitchFamily="34" charset="0"/>
              </a:rPr>
              <a:t>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>
            <a:off x="1535431" y="534475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2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3592831" y="5352046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5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5725210" y="5352046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smtClean="0">
                <a:latin typeface="Arial" pitchFamily="34" charset="0"/>
                <a:cs typeface="Arial" pitchFamily="34" charset="0"/>
              </a:rPr>
              <a:t>7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1535431" y="7086600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>
                <a:latin typeface="Arial" pitchFamily="34" charset="0"/>
                <a:cs typeface="Arial" pitchFamily="34" charset="0"/>
              </a:rPr>
              <a:t>3</a:t>
            </a:r>
            <a:r>
              <a:rPr lang="es-AR" sz="1100" b="1" dirty="0" smtClean="0">
                <a:latin typeface="Arial" pitchFamily="34" charset="0"/>
                <a:cs typeface="Arial" pitchFamily="34" charset="0"/>
              </a:rPr>
              <a:t>A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>
            <a:off x="3592831" y="70938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>
                <a:latin typeface="Arial" pitchFamily="34" charset="0"/>
                <a:cs typeface="Arial" pitchFamily="34" charset="0"/>
              </a:rPr>
              <a:t>5</a:t>
            </a:r>
            <a:r>
              <a:rPr lang="es-AR" sz="1100" b="1" dirty="0" smtClean="0">
                <a:latin typeface="Arial" pitchFamily="34" charset="0"/>
                <a:cs typeface="Arial" pitchFamily="34" charset="0"/>
              </a:rPr>
              <a:t>B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5638801" y="7093888"/>
            <a:ext cx="578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b="1" dirty="0" err="1" smtClean="0">
                <a:latin typeface="Arial" pitchFamily="34" charset="0"/>
                <a:cs typeface="Arial" pitchFamily="34" charset="0"/>
              </a:rPr>
              <a:t>Unk</a:t>
            </a:r>
            <a:endParaRPr lang="es-ES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" name="Picture 3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47"/>
          <a:stretch/>
        </p:blipFill>
        <p:spPr bwMode="auto">
          <a:xfrm>
            <a:off x="6248400" y="2514601"/>
            <a:ext cx="448714" cy="3880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112170" y="8763000"/>
            <a:ext cx="1716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dirty="0" smtClean="0">
                <a:latin typeface="Arial" pitchFamily="34" charset="0"/>
                <a:cs typeface="Arial" pitchFamily="34" charset="0"/>
              </a:rPr>
              <a:t>Fig. S3a</a:t>
            </a:r>
          </a:p>
        </p:txBody>
      </p:sp>
    </p:spTree>
    <p:extLst>
      <p:ext uri="{BB962C8B-B14F-4D97-AF65-F5344CB8AC3E}">
        <p14:creationId xmlns:p14="http://schemas.microsoft.com/office/powerpoint/2010/main" val="28970650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112170" y="8763000"/>
            <a:ext cx="1716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dirty="0" smtClean="0">
                <a:latin typeface="Arial" pitchFamily="34" charset="0"/>
                <a:cs typeface="Arial" pitchFamily="34" charset="0"/>
              </a:rPr>
              <a:t>Fig. S3b</a:t>
            </a:r>
          </a:p>
        </p:txBody>
      </p:sp>
      <p:grpSp>
        <p:nvGrpSpPr>
          <p:cNvPr id="8" name="7 Grupo"/>
          <p:cNvGrpSpPr/>
          <p:nvPr/>
        </p:nvGrpSpPr>
        <p:grpSpPr>
          <a:xfrm>
            <a:off x="578299" y="1219201"/>
            <a:ext cx="5610726" cy="5985619"/>
            <a:chOff x="578299" y="1219200"/>
            <a:chExt cx="5610726" cy="5985619"/>
          </a:xfrm>
        </p:grpSpPr>
        <p:pic>
          <p:nvPicPr>
            <p:cNvPr id="1026" name="Picture 2" descr="C:\Users\Pablo\Documents\LABORAL\INVESTIGACION\PUBLICACIONES\Publicaciones en curso\2016 GENETIC STRUCTURE USING SNPs\ANALISIS\DESEQ LIGAMIENTO\TASSEL\LD\LD ALL 4854 TASSEL5.png"/>
            <p:cNvPicPr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674" y="1718419"/>
              <a:ext cx="5486400" cy="548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5 CuadroTexto"/>
            <p:cNvSpPr txBox="1"/>
            <p:nvPr/>
          </p:nvSpPr>
          <p:spPr>
            <a:xfrm>
              <a:off x="578299" y="1219200"/>
              <a:ext cx="561072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AR" sz="2400" dirty="0" err="1" smtClean="0">
                  <a:latin typeface="Arial" pitchFamily="34" charset="0"/>
                  <a:cs typeface="Arial" pitchFamily="34" charset="0"/>
                </a:rPr>
                <a:t>Whole</a:t>
              </a:r>
              <a:r>
                <a:rPr lang="es-AR" sz="24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AR" sz="2400" dirty="0" err="1" smtClean="0">
                  <a:latin typeface="Arial" pitchFamily="34" charset="0"/>
                  <a:cs typeface="Arial" pitchFamily="34" charset="0"/>
                </a:rPr>
                <a:t>genome</a:t>
              </a:r>
              <a:r>
                <a:rPr lang="es-AR" sz="2400" dirty="0" smtClean="0">
                  <a:latin typeface="Arial" pitchFamily="34" charset="0"/>
                  <a:cs typeface="Arial" pitchFamily="34" charset="0"/>
                </a:rPr>
                <a:t> LD</a:t>
              </a:r>
              <a:endParaRPr lang="es-ES" sz="24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216565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2</TotalTime>
  <Words>146</Words>
  <Application>Microsoft Office PowerPoint</Application>
  <PresentationFormat>Presentación en pantalla (4:3)</PresentationFormat>
  <Paragraphs>31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12</cp:revision>
  <dcterms:created xsi:type="dcterms:W3CDTF">2020-08-17T17:37:03Z</dcterms:created>
  <dcterms:modified xsi:type="dcterms:W3CDTF">2021-01-06T10:56:53Z</dcterms:modified>
</cp:coreProperties>
</file>